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6"/>
  </p:notesMasterIdLst>
  <p:sldIdLst>
    <p:sldId id="25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1AC8A"/>
    <a:srgbClr val="FFFFFF"/>
    <a:srgbClr val="532E8D"/>
    <a:srgbClr val="296DC0"/>
    <a:srgbClr val="FB794D"/>
    <a:srgbClr val="D5FFF7"/>
    <a:srgbClr val="FF542C"/>
    <a:srgbClr val="532E90"/>
    <a:srgbClr val="39B882"/>
    <a:srgbClr val="56278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70"/>
    <p:restoredTop sz="94694"/>
  </p:normalViewPr>
  <p:slideViewPr>
    <p:cSldViewPr snapToGrid="0" snapToObjects="1">
      <p:cViewPr varScale="1">
        <p:scale>
          <a:sx n="91" d="100"/>
          <a:sy n="91" d="100"/>
        </p:scale>
        <p:origin x="70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A2D955-F89A-433C-93A8-D331D95A6C34}" type="datetimeFigureOut">
              <a:rPr lang="da-DK" smtClean="0"/>
              <a:t>12-09-2025</a:t>
            </a:fld>
            <a:endParaRPr lang="da-DK"/>
          </a:p>
        </p:txBody>
      </p:sp>
      <p:sp>
        <p:nvSpPr>
          <p:cNvPr id="4" name="Pladsholder til slidebilled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a-DK"/>
          </a:p>
        </p:txBody>
      </p:sp>
      <p:sp>
        <p:nvSpPr>
          <p:cNvPr id="5" name="Pladsholder til no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F44BA1-1E5D-4683-8782-99486912E6FC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0668490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B0934A-73F7-1F4D-8E48-3E4A6021BA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5CDD2B-C91F-C94C-859A-713BFC4DD1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91ED89-A522-574C-BEF6-23952F3B4B57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6863A7-7AEA-9B47-919A-F8290FDF7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907878-B1BF-934B-B3EE-C0F2BF772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962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16CE03-BAB6-DF4C-8DDE-EDF8B40D5F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739278-2F15-C545-AAAE-F43E2A6854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2E6775-CD32-3142-8FBA-CDFB263F3F2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61732B-9114-794D-A840-56608EFFA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87E824-670B-F54F-B320-0C9D58D344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006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A98D59E-1E91-6442-B486-69DCB6DED4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C48020-99DE-034A-896B-B168AFB238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B4BD8C-E04E-344D-BCA3-4A12AF9F9FD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22BA77-B54E-294B-8E51-618E05266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87FCA8-BA90-3541-B0B2-65F59CAACB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543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11FE32-5B64-E243-9843-A1EA2051C3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68202A-F2E5-FC45-ACF7-E80F6D7F88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4E0E2A-40A9-9E49-9929-3C392D31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FC6A75-50A7-FD48-9F8D-FB2C39DA3A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3C649F-74CE-F84F-B801-BA6564F4E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93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C92EFB-E534-0B42-82B0-D66CA3A68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ED4610-C5DA-DD4F-87FA-011B5B738A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9B7977-8B5A-5F4D-A953-66956B975D5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9D024F-74DA-F747-9F3F-12FC38574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B084D1-6F99-7B4A-86C4-626B3DBD42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964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EB8CA2-0484-E046-B109-39812C272F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398EB0-FE7C-194F-ADF9-152ECCB395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031F7A-AE90-1B46-AE9B-15C84FAB35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1FA71C-8983-674C-A8D8-7A92D4E77443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CCBC2C-F5E8-8B44-AAF8-57C9F683B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138B94-9D6F-7649-A1CE-5DF2873EAA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485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4A7FB-656F-2D44-BF6D-9A6296F5C5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ED082F-CF7B-6640-B0DD-47812C442D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7A971E-FD89-D045-859D-668111E877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7CA272-0B40-1C4C-8651-B6B649E82C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BA28564-A83D-3D41-9326-EE04008E1C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26F9878-94A7-D440-9A77-51A1EA8F785D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13572D8-65D0-A74D-9157-DA78839BAC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67A03D-FD78-174E-A057-4CDF5DE3C8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5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B3D4D0-427F-3644-AE9F-7F9F02C8FE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A6876D9-D8F4-3E46-AD79-3F1CA5075968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D88B33-B404-7D49-8C6E-72E7BEE54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4BF84DA-594E-BF46-A0F9-E98ECA299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203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C642915-FDC1-FB40-B2EA-C81621B13A4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282C27-207A-D143-B2F5-5ACDD3A0A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63BDB4-97C0-664F-82A9-FDEED8DC8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0744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B6FD49-22F7-6342-8EB6-58DC854D98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738B74-02DD-4E41-B862-2E393D02CC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63CE6A-13AB-674E-94BC-02C05CBD26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D367F2-1863-8745-B0C0-223C48254926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2BA1F2-4205-3B42-9CA2-608CF7CB1D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671325-42DD-9D4C-BA1C-C3F3E0481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970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737B78-070F-F345-B4F5-2CD85DB00F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3A062D-BBBC-9E4F-BB12-301E15D789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B13057-E866-B245-8719-C8F338C3C0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D9CA1E-011F-874B-B115-68686FE8F4EC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22A0C4-99AA-1345-9159-65D57E98C6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17377B-6239-5143-A68F-90A23176B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895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844040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reeform 15">
            <a:extLst>
              <a:ext uri="{FF2B5EF4-FFF2-40B4-BE49-F238E27FC236}">
                <a16:creationId xmlns:a16="http://schemas.microsoft.com/office/drawing/2014/main" id="{2F7EBDCF-7104-BE4E-A6DC-608D64D62DDC}"/>
              </a:ext>
            </a:extLst>
          </p:cNvPr>
          <p:cNvSpPr/>
          <p:nvPr/>
        </p:nvSpPr>
        <p:spPr>
          <a:xfrm>
            <a:off x="0" y="842363"/>
            <a:ext cx="12192000" cy="558855"/>
          </a:xfrm>
          <a:custGeom>
            <a:avLst/>
            <a:gdLst>
              <a:gd name="connsiteX0" fmla="*/ 0 w 12192000"/>
              <a:gd name="connsiteY0" fmla="*/ 0 h 558855"/>
              <a:gd name="connsiteX1" fmla="*/ 12192000 w 12192000"/>
              <a:gd name="connsiteY1" fmla="*/ 0 h 558855"/>
              <a:gd name="connsiteX2" fmla="*/ 12192000 w 12192000"/>
              <a:gd name="connsiteY2" fmla="*/ 491090 h 558855"/>
              <a:gd name="connsiteX3" fmla="*/ 550011 w 12192000"/>
              <a:gd name="connsiteY3" fmla="*/ 491090 h 558855"/>
              <a:gd name="connsiteX4" fmla="*/ 461865 w 12192000"/>
              <a:gd name="connsiteY4" fmla="*/ 558855 h 558855"/>
              <a:gd name="connsiteX5" fmla="*/ 373720 w 12192000"/>
              <a:gd name="connsiteY5" fmla="*/ 491090 h 558855"/>
              <a:gd name="connsiteX6" fmla="*/ 0 w 12192000"/>
              <a:gd name="connsiteY6" fmla="*/ 491090 h 5588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12192000" h="558855">
                <a:moveTo>
                  <a:pt x="0" y="0"/>
                </a:moveTo>
                <a:lnTo>
                  <a:pt x="12192000" y="0"/>
                </a:lnTo>
                <a:lnTo>
                  <a:pt x="12192000" y="491090"/>
                </a:lnTo>
                <a:lnTo>
                  <a:pt x="550011" y="491090"/>
                </a:lnTo>
                <a:lnTo>
                  <a:pt x="461865" y="558855"/>
                </a:lnTo>
                <a:lnTo>
                  <a:pt x="373720" y="491090"/>
                </a:lnTo>
                <a:lnTo>
                  <a:pt x="0" y="491090"/>
                </a:lnTo>
                <a:close/>
              </a:path>
            </a:pathLst>
          </a:custGeom>
          <a:solidFill>
            <a:srgbClr val="532E8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r>
              <a:rPr dirty="0"/>
              <a:t>Hypothesis: Dietitian–staff PDSA cycles improve hip fracture nutrition care.</a:t>
            </a:r>
          </a:p>
        </p:txBody>
      </p:sp>
      <p:sp>
        <p:nvSpPr>
          <p:cNvPr id="18" name="Freeform 17">
            <a:extLst>
              <a:ext uri="{FF2B5EF4-FFF2-40B4-BE49-F238E27FC236}">
                <a16:creationId xmlns:a16="http://schemas.microsoft.com/office/drawing/2014/main" id="{37280049-FB0A-644C-9F04-2F2702212101}"/>
              </a:ext>
            </a:extLst>
          </p:cNvPr>
          <p:cNvSpPr/>
          <p:nvPr/>
        </p:nvSpPr>
        <p:spPr>
          <a:xfrm>
            <a:off x="0" y="-1"/>
            <a:ext cx="12192000" cy="931754"/>
          </a:xfrm>
          <a:custGeom>
            <a:avLst/>
            <a:gdLst>
              <a:gd name="connsiteX0" fmla="*/ 0 w 12192000"/>
              <a:gd name="connsiteY0" fmla="*/ 0 h 931754"/>
              <a:gd name="connsiteX1" fmla="*/ 12192000 w 12192000"/>
              <a:gd name="connsiteY1" fmla="*/ 0 h 931754"/>
              <a:gd name="connsiteX2" fmla="*/ 12192000 w 12192000"/>
              <a:gd name="connsiteY2" fmla="*/ 861849 h 931754"/>
              <a:gd name="connsiteX3" fmla="*/ 550506 w 12192000"/>
              <a:gd name="connsiteY3" fmla="*/ 861849 h 931754"/>
              <a:gd name="connsiteX4" fmla="*/ 550506 w 12192000"/>
              <a:gd name="connsiteY4" fmla="*/ 863608 h 931754"/>
              <a:gd name="connsiteX5" fmla="*/ 461865 w 12192000"/>
              <a:gd name="connsiteY5" fmla="*/ 931754 h 931754"/>
              <a:gd name="connsiteX6" fmla="*/ 373224 w 12192000"/>
              <a:gd name="connsiteY6" fmla="*/ 863608 h 931754"/>
              <a:gd name="connsiteX7" fmla="*/ 373224 w 12192000"/>
              <a:gd name="connsiteY7" fmla="*/ 861849 h 931754"/>
              <a:gd name="connsiteX8" fmla="*/ 0 w 12192000"/>
              <a:gd name="connsiteY8" fmla="*/ 861849 h 93175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2192000" h="931754">
                <a:moveTo>
                  <a:pt x="0" y="0"/>
                </a:moveTo>
                <a:lnTo>
                  <a:pt x="12192000" y="0"/>
                </a:lnTo>
                <a:lnTo>
                  <a:pt x="12192000" y="861849"/>
                </a:lnTo>
                <a:lnTo>
                  <a:pt x="550506" y="861849"/>
                </a:lnTo>
                <a:lnTo>
                  <a:pt x="550506" y="863608"/>
                </a:lnTo>
                <a:lnTo>
                  <a:pt x="461865" y="931754"/>
                </a:lnTo>
                <a:lnTo>
                  <a:pt x="373224" y="863608"/>
                </a:lnTo>
                <a:lnTo>
                  <a:pt x="373224" y="861849"/>
                </a:lnTo>
                <a:lnTo>
                  <a:pt x="0" y="861849"/>
                </a:lnTo>
                <a:close/>
              </a:path>
            </a:pathLst>
          </a:custGeom>
          <a:solidFill>
            <a:srgbClr val="01AC8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6F715CD7-84CB-2340-94B4-1576D6B34904}"/>
              </a:ext>
            </a:extLst>
          </p:cNvPr>
          <p:cNvSpPr/>
          <p:nvPr/>
        </p:nvSpPr>
        <p:spPr>
          <a:xfrm>
            <a:off x="0" y="5215813"/>
            <a:ext cx="12191999" cy="934456"/>
          </a:xfrm>
          <a:prstGeom prst="rect">
            <a:avLst/>
          </a:prstGeom>
          <a:solidFill>
            <a:srgbClr val="532E8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1F065340-06FA-FF44-A702-686194FC8BF4}"/>
              </a:ext>
            </a:extLst>
          </p:cNvPr>
          <p:cNvSpPr/>
          <p:nvPr/>
        </p:nvSpPr>
        <p:spPr>
          <a:xfrm>
            <a:off x="8826758" y="-8183"/>
            <a:ext cx="3365241" cy="13603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964DB466-5B38-432F-BE28-3E89357CF52C}"/>
              </a:ext>
            </a:extLst>
          </p:cNvPr>
          <p:cNvSpPr/>
          <p:nvPr/>
        </p:nvSpPr>
        <p:spPr>
          <a:xfrm>
            <a:off x="-5540" y="-5856"/>
            <a:ext cx="8660441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16000"/>
            <a:r>
              <a:rPr lang="en-US" sz="1800" b="1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Effects of a Dietitian-supported Multidisciplinary Nutritional Intervention on optimizing Nutritional care in older Patients with Hip Fracture and at Nutrition Risk - a quality improvement study</a:t>
            </a:r>
            <a:endParaRPr lang="da-DK" sz="1800" dirty="0">
              <a:solidFill>
                <a:srgbClr val="333333"/>
              </a:solidFill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2" name="TextBox 25">
            <a:extLst>
              <a:ext uri="{FF2B5EF4-FFF2-40B4-BE49-F238E27FC236}">
                <a16:creationId xmlns:a16="http://schemas.microsoft.com/office/drawing/2014/main" id="{2FA921B7-76FA-4CBC-8EE0-9372E6EAA46D}"/>
              </a:ext>
            </a:extLst>
          </p:cNvPr>
          <p:cNvSpPr txBox="1"/>
          <p:nvPr/>
        </p:nvSpPr>
        <p:spPr>
          <a:xfrm>
            <a:off x="105104" y="1731638"/>
            <a:ext cx="6432331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dirty="0"/>
              <a:t>Design: Quality improvement study using the Model for Improvement (Sep–Dec 2024)</a:t>
            </a:r>
          </a:p>
          <a:p>
            <a:r>
              <a:rPr dirty="0"/>
              <a:t>• Clinical dietitian embedded in orthopedic ward</a:t>
            </a:r>
          </a:p>
          <a:p>
            <a:r>
              <a:rPr dirty="0"/>
              <a:t>• Two PDSA cycles focused on:</a:t>
            </a:r>
          </a:p>
          <a:p>
            <a:r>
              <a:rPr dirty="0"/>
              <a:t>   - Nutritional documentation</a:t>
            </a:r>
          </a:p>
          <a:p>
            <a:r>
              <a:rPr dirty="0"/>
              <a:t>   - Nutritional intake</a:t>
            </a:r>
          </a:p>
          <a:p>
            <a:endParaRPr dirty="0"/>
          </a:p>
          <a:p>
            <a:r>
              <a:rPr dirty="0"/>
              <a:t>Outcomes:</a:t>
            </a:r>
          </a:p>
          <a:p>
            <a:r>
              <a:rPr dirty="0"/>
              <a:t>• Patients meeting requirements: 22% → 80%</a:t>
            </a:r>
          </a:p>
          <a:p>
            <a:r>
              <a:rPr dirty="0"/>
              <a:t>• Nutritional risk screening: 10% → 80%</a:t>
            </a:r>
          </a:p>
          <a:p>
            <a:r>
              <a:rPr dirty="0"/>
              <a:t>• Intake documentation: 30% → 100%</a:t>
            </a:r>
          </a:p>
        </p:txBody>
      </p:sp>
      <p:sp>
        <p:nvSpPr>
          <p:cNvPr id="23" name="TextBox 27">
            <a:extLst>
              <a:ext uri="{FF2B5EF4-FFF2-40B4-BE49-F238E27FC236}">
                <a16:creationId xmlns:a16="http://schemas.microsoft.com/office/drawing/2014/main" id="{C4A24716-2396-4C25-9B20-10E6EDE15AC5}"/>
              </a:ext>
            </a:extLst>
          </p:cNvPr>
          <p:cNvSpPr txBox="1"/>
          <p:nvPr/>
        </p:nvSpPr>
        <p:spPr>
          <a:xfrm>
            <a:off x="-1" y="5232683"/>
            <a:ext cx="121975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dirty="0">
                <a:solidFill>
                  <a:schemeClr val="bg1"/>
                </a:solidFill>
              </a:rPr>
              <a:t>CONCLUSION: Dietitian-led PDSA cycles improved interdisciplinary nutrition care, increasing intake, screening, and documentation.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FEE1F08-1F18-49D3-B4CC-0DC3969337EF}"/>
              </a:ext>
            </a:extLst>
          </p:cNvPr>
          <p:cNvSpPr txBox="1"/>
          <p:nvPr/>
        </p:nvSpPr>
        <p:spPr>
          <a:xfrm>
            <a:off x="194908" y="6275165"/>
            <a:ext cx="32775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532E8D"/>
                </a:solidFill>
                <a:latin typeface="+mj-lt"/>
              </a:rPr>
              <a:t>[Munk et al. 2025]</a:t>
            </a:r>
            <a:endParaRPr lang="en-GB" sz="1200" b="1" dirty="0">
              <a:solidFill>
                <a:srgbClr val="532E8D"/>
              </a:solidFill>
              <a:latin typeface="+mj-lt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298E6C5-9080-7281-502B-E200CCE87EDA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9584"/>
          <a:stretch/>
        </p:blipFill>
        <p:spPr>
          <a:xfrm>
            <a:off x="8902262" y="16813"/>
            <a:ext cx="3295277" cy="1232581"/>
          </a:xfrm>
          <a:prstGeom prst="rect">
            <a:avLst/>
          </a:prstGeom>
        </p:spPr>
      </p:pic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624200C0-3223-F0F5-B4AC-2C7EEB5C6E07}"/>
              </a:ext>
            </a:extLst>
          </p:cNvPr>
          <p:cNvCxnSpPr/>
          <p:nvPr/>
        </p:nvCxnSpPr>
        <p:spPr>
          <a:xfrm>
            <a:off x="0" y="1369734"/>
            <a:ext cx="12192000" cy="0"/>
          </a:xfrm>
          <a:prstGeom prst="line">
            <a:avLst/>
          </a:prstGeom>
          <a:ln w="76200">
            <a:solidFill>
              <a:srgbClr val="FF542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50" name="Picture 2" descr="American Society for Parenteral and Enteral Nutrition">
            <a:extLst>
              <a:ext uri="{FF2B5EF4-FFF2-40B4-BE49-F238E27FC236}">
                <a16:creationId xmlns:a16="http://schemas.microsoft.com/office/drawing/2014/main" id="{21089BE1-4EB1-4C6F-ACC7-76531A29F87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10749" y="6150269"/>
            <a:ext cx="2381250" cy="6191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Billede 4">
            <a:extLst>
              <a:ext uri="{FF2B5EF4-FFF2-40B4-BE49-F238E27FC236}">
                <a16:creationId xmlns:a16="http://schemas.microsoft.com/office/drawing/2014/main" id="{6D4BB05A-8D99-7C53-485F-09FB3EDB71BF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4892" b="1093"/>
          <a:stretch/>
        </p:blipFill>
        <p:spPr>
          <a:xfrm>
            <a:off x="5780690" y="1596662"/>
            <a:ext cx="6243144" cy="34942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50800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B32E07EFAD3E54C82B0ADD6F67780BC" ma:contentTypeVersion="12" ma:contentTypeDescription="Create a new document." ma:contentTypeScope="" ma:versionID="ae816242d01d668c2db721fa9edcdf46">
  <xsd:schema xmlns:xsd="http://www.w3.org/2001/XMLSchema" xmlns:xs="http://www.w3.org/2001/XMLSchema" xmlns:p="http://schemas.microsoft.com/office/2006/metadata/properties" xmlns:ns3="4748f3cc-a7b3-4f74-9c2f-91806ac88731" xmlns:ns4="a50305bf-f20c-45b5-95fe-0c3b9f2af3a3" targetNamespace="http://schemas.microsoft.com/office/2006/metadata/properties" ma:root="true" ma:fieldsID="8ca5950ea94b62bb1bf2a602428f57fa" ns3:_="" ns4:_="">
    <xsd:import namespace="4748f3cc-a7b3-4f74-9c2f-91806ac88731"/>
    <xsd:import namespace="a50305bf-f20c-45b5-95fe-0c3b9f2af3a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748f3cc-a7b3-4f74-9c2f-91806ac8873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50305bf-f20c-45b5-95fe-0c3b9f2af3a3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7E85C07C-ED92-468F-ADCD-68FCA18E72E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748f3cc-a7b3-4f74-9c2f-91806ac88731"/>
    <ds:schemaRef ds:uri="a50305bf-f20c-45b5-95fe-0c3b9f2af3a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952490DB-A17C-4E96-B3C6-7A6120172BC3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7FC2848-6B7E-4378-81B4-50ED554E686C}">
  <ds:schemaRefs>
    <ds:schemaRef ds:uri="http://purl.org/dc/dcmitype/"/>
    <ds:schemaRef ds:uri="http://schemas.openxmlformats.org/package/2006/metadata/core-properties"/>
    <ds:schemaRef ds:uri="4748f3cc-a7b3-4f74-9c2f-91806ac88731"/>
    <ds:schemaRef ds:uri="http://schemas.microsoft.com/office/2006/documentManagement/types"/>
    <ds:schemaRef ds:uri="http://purl.org/dc/terms/"/>
    <ds:schemaRef ds:uri="a50305bf-f20c-45b5-95fe-0c3b9f2af3a3"/>
    <ds:schemaRef ds:uri="http://schemas.microsoft.com/office/infopath/2007/PartnerControls"/>
    <ds:schemaRef ds:uri="http://schemas.microsoft.com/office/2006/metadata/properties"/>
    <ds:schemaRef ds:uri="http://www.w3.org/XML/1998/namespace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64</TotalTime>
  <Words>134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3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5" baseType="lpstr">
      <vt:lpstr>Aptos</vt:lpstr>
      <vt:lpstr>Arial</vt:lpstr>
      <vt:lpstr>Times New Roman</vt:lpstr>
      <vt:lpstr>Office Theme</vt:lpstr>
      <vt:lpstr>PowerPoint-præ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G Ison</dc:creator>
  <cp:lastModifiedBy>Tina Munk</cp:lastModifiedBy>
  <cp:revision>21</cp:revision>
  <dcterms:created xsi:type="dcterms:W3CDTF">2021-10-22T20:34:26Z</dcterms:created>
  <dcterms:modified xsi:type="dcterms:W3CDTF">2025-09-12T20:18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B32E07EFAD3E54C82B0ADD6F67780BC</vt:lpwstr>
  </property>
</Properties>
</file>